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57" r:id="rId2"/>
    <p:sldId id="258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B99724B-4CF4-AE3F-A536-589DFE468D68}" name="Cajsa Aranäs" initials="CA" userId="S::cajsa.aranas@gu.se::1bdf1a7e-994c-4d98-bb3b-1454526e223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8008"/>
    <p:restoredTop sz="86438"/>
  </p:normalViewPr>
  <p:slideViewPr>
    <p:cSldViewPr snapToGrid="0">
      <p:cViewPr>
        <p:scale>
          <a:sx n="133" d="100"/>
          <a:sy n="133" d="100"/>
        </p:scale>
        <p:origin x="3528" y="-332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AB558A-B1F5-1F43-8CAC-1BE4F24C1286}" type="datetimeFigureOut">
              <a:rPr lang="en-SE" smtClean="0"/>
              <a:t>4/25/25</a:t>
            </a:fld>
            <a:endParaRPr lang="en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F91344-07FC-CD46-8BEB-D9E869CE386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0948279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F91344-07FC-CD46-8BEB-D9E869CE386A}" type="slidenum">
              <a:rPr lang="en-SE" smtClean="0"/>
              <a:t>1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1058691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F91344-07FC-CD46-8BEB-D9E869CE386A}" type="slidenum">
              <a:rPr lang="en-SE" smtClean="0"/>
              <a:t>2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26712771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00FDFD9-EE69-2250-DC9D-1ED68643F1F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FAA0DFF2-BF67-FE11-680A-ACDDF2CA73B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C7DB46C-9D2D-7D5D-86FD-1CA84864125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387D34-A8B5-F0A1-189A-6D3CE4A48EB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F91344-07FC-CD46-8BEB-D9E869CE386A}" type="slidenum">
              <a:rPr lang="en-SE" smtClean="0"/>
              <a:t>3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3971820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789528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940228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163411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884002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915048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183787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856407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735316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207322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077542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899757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7DDACF5-9EE1-FA45-ADDA-2082C66C722A}" type="datetimeFigureOut">
              <a:rPr lang="en-SE" smtClean="0"/>
              <a:t>4/25/2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56C51A5-340A-C348-B2EA-E99275C6D3F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799124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9A079813-475E-5124-9364-3C7DC4C3EC9D}"/>
              </a:ext>
            </a:extLst>
          </p:cNvPr>
          <p:cNvGrpSpPr/>
          <p:nvPr/>
        </p:nvGrpSpPr>
        <p:grpSpPr>
          <a:xfrm>
            <a:off x="0" y="69012"/>
            <a:ext cx="6771736" cy="8791380"/>
            <a:chOff x="0" y="69012"/>
            <a:chExt cx="6771736" cy="879138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89911EE-5A24-807C-FE80-FD4504F8C33A}"/>
                </a:ext>
              </a:extLst>
            </p:cNvPr>
            <p:cNvSpPr txBox="1"/>
            <p:nvPr/>
          </p:nvSpPr>
          <p:spPr>
            <a:xfrm>
              <a:off x="172528" y="69012"/>
              <a:ext cx="27366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Supplementary Figure 1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CE510403-6B2E-F2B9-2E98-041553827B4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569388"/>
              <a:ext cx="5328063" cy="5366463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E02FE2D-8462-E1FA-EEC2-4C4C9A4516A9}"/>
                </a:ext>
              </a:extLst>
            </p:cNvPr>
            <p:cNvSpPr txBox="1"/>
            <p:nvPr/>
          </p:nvSpPr>
          <p:spPr>
            <a:xfrm>
              <a:off x="86264" y="6182736"/>
              <a:ext cx="6685472" cy="2677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effectLst/>
                  <a:latin typeface="Calibri" panose="020F0502020204030204" pitchFamily="34" charset="0"/>
                  <a:ea typeface="Aptos" panose="020B0004020202020204" pitchFamily="34" charset="0"/>
                  <a:cs typeface="Calibri" panose="020F0502020204030204" pitchFamily="34" charset="0"/>
                </a:rPr>
                <a:t>Supplementary Figure 1.</a:t>
              </a:r>
            </a:p>
            <a:p>
              <a:r>
                <a:rPr lang="en-US" sz="1200" dirty="0">
                  <a:latin typeface="Calibri" panose="020F0502020204030204" pitchFamily="34" charset="0"/>
                  <a:ea typeface="Aptos" panose="020B0004020202020204" pitchFamily="34" charset="0"/>
                  <a:cs typeface="Calibri" panose="020F0502020204030204" pitchFamily="34" charset="0"/>
                </a:rPr>
                <a:t>I</a:t>
              </a:r>
              <a:r>
                <a:rPr lang="en-US" sz="1200" dirty="0">
                  <a:effectLst/>
                  <a:latin typeface="Calibri" panose="020F0502020204030204" pitchFamily="34" charset="0"/>
                  <a:ea typeface="Aptos" panose="020B0004020202020204" pitchFamily="34" charset="0"/>
                  <a:cs typeface="Calibri" panose="020F0502020204030204" pitchFamily="34" charset="0"/>
                </a:rPr>
                <a:t>n male rats, low doses of the BHB salt (0.5 and 1 g/kg, SC) (A) increased the water intake 4,(B) but not 24 hours after treatment</a:t>
              </a:r>
              <a:r>
                <a:rPr lang="en-US" sz="1200" dirty="0">
                  <a:latin typeface="Calibri" panose="020F0502020204030204" pitchFamily="34" charset="0"/>
                  <a:ea typeface="Aptos" panose="020B0004020202020204" pitchFamily="34" charset="0"/>
                  <a:cs typeface="Calibri" panose="020F0502020204030204" pitchFamily="34" charset="0"/>
                </a:rPr>
                <a:t>. BHB salt treatment did not change the </a:t>
              </a:r>
              <a:r>
                <a:rPr lang="en-US" sz="1200" dirty="0">
                  <a:effectLst/>
                  <a:latin typeface="Calibri" panose="020F0502020204030204" pitchFamily="34" charset="0"/>
                  <a:ea typeface="Aptos" panose="020B0004020202020204" pitchFamily="34" charset="0"/>
                  <a:cs typeface="Calibri" panose="020F0502020204030204" pitchFamily="34" charset="0"/>
                </a:rPr>
                <a:t>food intake at (C) the 4 or (D) the 24-hour tome point. (E) Neither did it influence the body weight of the male rats </a:t>
              </a:r>
            </a:p>
            <a:p>
              <a:endParaRPr 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en-US" sz="1200" dirty="0">
                  <a:effectLst/>
                  <a:latin typeface="Calibri" panose="020F0502020204030204" pitchFamily="34" charset="0"/>
                  <a:ea typeface="Aptos" panose="020B0004020202020204" pitchFamily="34" charset="0"/>
                  <a:cs typeface="Calibri" panose="020F0502020204030204" pitchFamily="34" charset="0"/>
                </a:rPr>
                <a:t>In female rats, BHB salt treatment increased the water intake at the (F) 4-hour and (G) 24-hour time points, an increase caused by both doses (0.5 and 1 g/kg, SC</a:t>
              </a:r>
              <a:r>
                <a:rPr lang="en-US" sz="1200" dirty="0">
                  <a:latin typeface="Calibri" panose="020F0502020204030204" pitchFamily="34" charset="0"/>
                  <a:ea typeface="Aptos" panose="020B0004020202020204" pitchFamily="34" charset="0"/>
                  <a:cs typeface="Calibri" panose="020F0502020204030204" pitchFamily="34" charset="0"/>
                </a:rPr>
                <a:t>). Furthermore, </a:t>
              </a:r>
              <a:r>
                <a:rPr lang="en-US" sz="1200" dirty="0">
                  <a:effectLst/>
                  <a:latin typeface="Calibri" panose="020F0502020204030204" pitchFamily="34" charset="0"/>
                  <a:ea typeface="Aptos" panose="020B0004020202020204" pitchFamily="34" charset="0"/>
                  <a:cs typeface="Calibri" panose="020F0502020204030204" pitchFamily="34" charset="0"/>
                </a:rPr>
                <a:t>(H) both doses of the BHB salt reduced the food intake 4 hours after treatment, (I) and 1 g/kg reduced the food intake 24 hours after treatment. (J) Twenty-four hours after treatment, the dose of 1 g/kg lowered the body weight.</a:t>
              </a:r>
            </a:p>
            <a:p>
              <a:endParaRPr lang="en-US" sz="12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endParaRPr>
            </a:p>
            <a:p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Data are presented as mean ±SEM. *P&lt;0.05, **P&lt;0.01, ***P&lt;0.001</a:t>
              </a:r>
              <a:endParaRPr lang="en-US" sz="12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endParaRPr>
            </a:p>
            <a:p>
              <a:endParaRPr lang="en-US" sz="12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endParaRPr>
            </a:p>
            <a:p>
              <a:endParaRPr lang="en-US" sz="12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endParaRPr>
            </a:p>
            <a:p>
              <a:endParaRPr 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0B56B2E-5E79-2E48-553F-1939D887F71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56394" t="58802" r="30057" b="34382"/>
            <a:stretch/>
          </p:blipFill>
          <p:spPr>
            <a:xfrm>
              <a:off x="4321743" y="3705726"/>
              <a:ext cx="721895" cy="36576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06185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282F5A-5666-1883-ABEC-8B3FB71B54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4A9E8A3-6C3A-5391-0DB7-2FEF4837D417}"/>
              </a:ext>
            </a:extLst>
          </p:cNvPr>
          <p:cNvSpPr txBox="1"/>
          <p:nvPr/>
        </p:nvSpPr>
        <p:spPr>
          <a:xfrm>
            <a:off x="172528" y="69012"/>
            <a:ext cx="273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 err="1"/>
              <a:t>Supplementary</a:t>
            </a:r>
            <a:r>
              <a:rPr lang="sv-SE" b="1" dirty="0"/>
              <a:t> </a:t>
            </a:r>
            <a:r>
              <a:rPr lang="en-SE" b="1"/>
              <a:t>Figure </a:t>
            </a:r>
            <a:r>
              <a:rPr lang="sv-SE" b="1" dirty="0"/>
              <a:t>2</a:t>
            </a:r>
            <a:endParaRPr lang="en-SE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19A681D-2E9F-4EEB-FE76-D249AAF080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0" y="438344"/>
            <a:ext cx="5765917" cy="580747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AC1965F-D036-8D9B-3AC2-8FF12E4D9076}"/>
              </a:ext>
            </a:extLst>
          </p:cNvPr>
          <p:cNvSpPr txBox="1"/>
          <p:nvPr/>
        </p:nvSpPr>
        <p:spPr>
          <a:xfrm>
            <a:off x="86264" y="6171850"/>
            <a:ext cx="6685472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Supplementary Figure 2.</a:t>
            </a:r>
          </a:p>
          <a:p>
            <a:r>
              <a:rPr lang="en-US" sz="12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I</a:t>
            </a:r>
            <a:r>
              <a:rPr lang="en-US" sz="12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n male rats, higher doses of the BHB salt (2 and 3 g/kg, SC) (A) increased the water intake 4,and (B) 24 hours after treatment</a:t>
            </a:r>
            <a:r>
              <a:rPr lang="en-US" sz="12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. BHB salt treatment lowered the </a:t>
            </a:r>
            <a:r>
              <a:rPr lang="en-US" sz="12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food intake at (C) the 4- and (D) the 24-hour time point. (E) However, neither does influence the body weight of the male rats </a:t>
            </a:r>
          </a:p>
          <a:p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2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In female rats, BHB salt treatment (2 and 3 g/kg, SC) elevated the water intake at the (F) 4-hour and (G) 24-hour time points</a:t>
            </a:r>
            <a:r>
              <a:rPr lang="en-US" sz="12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. Furthermore, </a:t>
            </a:r>
            <a:r>
              <a:rPr lang="en-US" sz="12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(H) both doses of the BHB salt reduced the food intake 4 hours after treatment, (I) and 3 g/kg reduced the food intake 24 hours after treatment. (J</a:t>
            </a:r>
            <a:r>
              <a:rPr lang="en-US" sz="12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) However, neither does influence the body weight of the female rats </a:t>
            </a:r>
          </a:p>
          <a:p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Data are presented as mean ±SEM. *P&lt;0.05, **P&lt;0.01, ***P&lt;0.001.</a:t>
            </a:r>
          </a:p>
        </p:txBody>
      </p:sp>
    </p:spTree>
    <p:extLst>
      <p:ext uri="{BB962C8B-B14F-4D97-AF65-F5344CB8AC3E}">
        <p14:creationId xmlns:p14="http://schemas.microsoft.com/office/powerpoint/2010/main" val="23663598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8BBDB6-FD8E-E69C-056E-9BF980896F5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1935B3B-774A-420D-7127-6751C14A1A3E}"/>
              </a:ext>
            </a:extLst>
          </p:cNvPr>
          <p:cNvSpPr txBox="1"/>
          <p:nvPr/>
        </p:nvSpPr>
        <p:spPr>
          <a:xfrm>
            <a:off x="172528" y="69012"/>
            <a:ext cx="2734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 err="1"/>
              <a:t>Supplementary</a:t>
            </a:r>
            <a:r>
              <a:rPr lang="sv-SE" b="1" dirty="0"/>
              <a:t> </a:t>
            </a:r>
            <a:r>
              <a:rPr lang="en-SE" b="1"/>
              <a:t>Figure </a:t>
            </a:r>
            <a:r>
              <a:rPr lang="sv-SE" b="1" dirty="0"/>
              <a:t>3</a:t>
            </a:r>
            <a:endParaRPr lang="en-SE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622A949-7AD0-9CC0-FD84-DBDEAD798201}"/>
              </a:ext>
            </a:extLst>
          </p:cNvPr>
          <p:cNvSpPr txBox="1"/>
          <p:nvPr/>
        </p:nvSpPr>
        <p:spPr>
          <a:xfrm>
            <a:off x="86264" y="2988387"/>
            <a:ext cx="668547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Supplementary Figure </a:t>
            </a:r>
            <a:r>
              <a:rPr lang="en-US" sz="1200" b="1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3</a:t>
            </a:r>
            <a:endParaRPr lang="en-US" sz="1200" b="1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  <a:p>
            <a:r>
              <a:rPr lang="en-US" sz="12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I</a:t>
            </a:r>
            <a:r>
              <a:rPr lang="en-US" sz="12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n male mice, BHB salt (3 g/kg, SC) did neither influence the extracellular levels of (A) </a:t>
            </a:r>
            <a:r>
              <a:rPr lang="en-US" sz="12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serotonin nor </a:t>
            </a:r>
            <a:r>
              <a:rPr lang="en-US" sz="12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(B) the metabolite, 5HIAA in the nucleus </a:t>
            </a:r>
            <a:r>
              <a:rPr lang="en-US" sz="12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accumbens</a:t>
            </a:r>
            <a:r>
              <a:rPr lang="en-US" sz="1200" dirty="0"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.</a:t>
            </a:r>
          </a:p>
          <a:p>
            <a:endParaRPr lang="en-US" sz="12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Data are presented as mean ±SEM.</a:t>
            </a:r>
          </a:p>
          <a:p>
            <a:endParaRPr lang="en-US" sz="12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E81CCBF-329A-A02A-AC79-B7F60911F9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736" y="551315"/>
            <a:ext cx="6604000" cy="2324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3630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80</TotalTime>
  <Words>450</Words>
  <Application>Microsoft Macintosh PowerPoint</Application>
  <PresentationFormat>A4 Paper (210x297 mm)</PresentationFormat>
  <Paragraphs>23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jsa Aranäs</dc:creator>
  <cp:lastModifiedBy>Elisabet Jerlhag Holm</cp:lastModifiedBy>
  <cp:revision>111</cp:revision>
  <dcterms:created xsi:type="dcterms:W3CDTF">2024-04-07T06:44:42Z</dcterms:created>
  <dcterms:modified xsi:type="dcterms:W3CDTF">2025-04-25T12:25:24Z</dcterms:modified>
</cp:coreProperties>
</file>